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24688800" cy="258730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80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51660" y="4234322"/>
            <a:ext cx="20985480" cy="9007663"/>
          </a:xfrm>
        </p:spPr>
        <p:txBody>
          <a:bodyPr anchor="b"/>
          <a:lstStyle>
            <a:lvl1pPr algn="ctr">
              <a:defRPr sz="16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086100" y="13589355"/>
            <a:ext cx="18516600" cy="6246669"/>
          </a:xfrm>
        </p:spPr>
        <p:txBody>
          <a:bodyPr/>
          <a:lstStyle>
            <a:lvl1pPr marL="0" indent="0" algn="ctr">
              <a:buNone/>
              <a:defRPr sz="6480"/>
            </a:lvl1pPr>
            <a:lvl2pPr marL="1234440" indent="0" algn="ctr">
              <a:buNone/>
              <a:defRPr sz="5400"/>
            </a:lvl2pPr>
            <a:lvl3pPr marL="2468880" indent="0" algn="ctr">
              <a:buNone/>
              <a:defRPr sz="4860"/>
            </a:lvl3pPr>
            <a:lvl4pPr marL="3703320" indent="0" algn="ctr">
              <a:buNone/>
              <a:defRPr sz="4320"/>
            </a:lvl4pPr>
            <a:lvl5pPr marL="4937760" indent="0" algn="ctr">
              <a:buNone/>
              <a:defRPr sz="4320"/>
            </a:lvl5pPr>
            <a:lvl6pPr marL="6172200" indent="0" algn="ctr">
              <a:buNone/>
              <a:defRPr sz="4320"/>
            </a:lvl6pPr>
            <a:lvl7pPr marL="7406640" indent="0" algn="ctr">
              <a:buNone/>
              <a:defRPr sz="4320"/>
            </a:lvl7pPr>
            <a:lvl8pPr marL="8641080" indent="0" algn="ctr">
              <a:buNone/>
              <a:defRPr sz="4320"/>
            </a:lvl8pPr>
            <a:lvl9pPr marL="9875520" indent="0" algn="ctr">
              <a:buNone/>
              <a:defRPr sz="432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830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640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667924" y="1377502"/>
            <a:ext cx="5323523" cy="2192623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97356" y="1377502"/>
            <a:ext cx="15661958" cy="2192623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3000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241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84498" y="6450309"/>
            <a:ext cx="21294090" cy="10762479"/>
          </a:xfrm>
        </p:spPr>
        <p:txBody>
          <a:bodyPr anchor="b"/>
          <a:lstStyle>
            <a:lvl1pPr>
              <a:defRPr sz="16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84498" y="17314605"/>
            <a:ext cx="21294090" cy="5659733"/>
          </a:xfrm>
        </p:spPr>
        <p:txBody>
          <a:bodyPr/>
          <a:lstStyle>
            <a:lvl1pPr marL="0" indent="0">
              <a:buNone/>
              <a:defRPr sz="6480">
                <a:solidFill>
                  <a:schemeClr val="tx1"/>
                </a:solidFill>
              </a:defRPr>
            </a:lvl1pPr>
            <a:lvl2pPr marL="123444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2pPr>
            <a:lvl3pPr marL="2468880" indent="0">
              <a:buNone/>
              <a:defRPr sz="4860">
                <a:solidFill>
                  <a:schemeClr val="tx1">
                    <a:tint val="75000"/>
                  </a:schemeClr>
                </a:solidFill>
              </a:defRPr>
            </a:lvl3pPr>
            <a:lvl4pPr marL="370332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4pPr>
            <a:lvl5pPr marL="493776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5pPr>
            <a:lvl6pPr marL="617220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6pPr>
            <a:lvl7pPr marL="740664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7pPr>
            <a:lvl8pPr marL="864108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8pPr>
            <a:lvl9pPr marL="9875520" indent="0">
              <a:buNone/>
              <a:defRPr sz="4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725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97355" y="6887509"/>
            <a:ext cx="10492740" cy="1641622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498705" y="6887509"/>
            <a:ext cx="10492740" cy="1641622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758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1" y="1377507"/>
            <a:ext cx="21294090" cy="500093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00573" y="6342499"/>
            <a:ext cx="10444518" cy="3108361"/>
          </a:xfrm>
        </p:spPr>
        <p:txBody>
          <a:bodyPr anchor="b"/>
          <a:lstStyle>
            <a:lvl1pPr marL="0" indent="0">
              <a:buNone/>
              <a:defRPr sz="6480" b="1"/>
            </a:lvl1pPr>
            <a:lvl2pPr marL="1234440" indent="0">
              <a:buNone/>
              <a:defRPr sz="5400" b="1"/>
            </a:lvl2pPr>
            <a:lvl3pPr marL="2468880" indent="0">
              <a:buNone/>
              <a:defRPr sz="4860" b="1"/>
            </a:lvl3pPr>
            <a:lvl4pPr marL="3703320" indent="0">
              <a:buNone/>
              <a:defRPr sz="4320" b="1"/>
            </a:lvl4pPr>
            <a:lvl5pPr marL="4937760" indent="0">
              <a:buNone/>
              <a:defRPr sz="4320" b="1"/>
            </a:lvl5pPr>
            <a:lvl6pPr marL="6172200" indent="0">
              <a:buNone/>
              <a:defRPr sz="4320" b="1"/>
            </a:lvl6pPr>
            <a:lvl7pPr marL="7406640" indent="0">
              <a:buNone/>
              <a:defRPr sz="4320" b="1"/>
            </a:lvl7pPr>
            <a:lvl8pPr marL="8641080" indent="0">
              <a:buNone/>
              <a:defRPr sz="4320" b="1"/>
            </a:lvl8pPr>
            <a:lvl9pPr marL="9875520" indent="0">
              <a:buNone/>
              <a:defRPr sz="432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00573" y="9450859"/>
            <a:ext cx="10444518" cy="1390079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498706" y="6342499"/>
            <a:ext cx="10495956" cy="3108361"/>
          </a:xfrm>
        </p:spPr>
        <p:txBody>
          <a:bodyPr anchor="b"/>
          <a:lstStyle>
            <a:lvl1pPr marL="0" indent="0">
              <a:buNone/>
              <a:defRPr sz="6480" b="1"/>
            </a:lvl1pPr>
            <a:lvl2pPr marL="1234440" indent="0">
              <a:buNone/>
              <a:defRPr sz="5400" b="1"/>
            </a:lvl2pPr>
            <a:lvl3pPr marL="2468880" indent="0">
              <a:buNone/>
              <a:defRPr sz="4860" b="1"/>
            </a:lvl3pPr>
            <a:lvl4pPr marL="3703320" indent="0">
              <a:buNone/>
              <a:defRPr sz="4320" b="1"/>
            </a:lvl4pPr>
            <a:lvl5pPr marL="4937760" indent="0">
              <a:buNone/>
              <a:defRPr sz="4320" b="1"/>
            </a:lvl5pPr>
            <a:lvl6pPr marL="6172200" indent="0">
              <a:buNone/>
              <a:defRPr sz="4320" b="1"/>
            </a:lvl6pPr>
            <a:lvl7pPr marL="7406640" indent="0">
              <a:buNone/>
              <a:defRPr sz="4320" b="1"/>
            </a:lvl7pPr>
            <a:lvl8pPr marL="8641080" indent="0">
              <a:buNone/>
              <a:defRPr sz="4320" b="1"/>
            </a:lvl8pPr>
            <a:lvl9pPr marL="9875520" indent="0">
              <a:buNone/>
              <a:defRPr sz="432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498706" y="9450859"/>
            <a:ext cx="10495956" cy="1390079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7477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47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777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1" y="1724872"/>
            <a:ext cx="7962781" cy="6037051"/>
          </a:xfrm>
        </p:spPr>
        <p:txBody>
          <a:bodyPr anchor="b"/>
          <a:lstStyle>
            <a:lvl1pPr>
              <a:defRPr sz="864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495956" y="3725249"/>
            <a:ext cx="12498705" cy="18386653"/>
          </a:xfrm>
        </p:spPr>
        <p:txBody>
          <a:bodyPr/>
          <a:lstStyle>
            <a:lvl1pPr>
              <a:defRPr sz="8640"/>
            </a:lvl1pPr>
            <a:lvl2pPr>
              <a:defRPr sz="7560"/>
            </a:lvl2pPr>
            <a:lvl3pPr>
              <a:defRPr sz="6480"/>
            </a:lvl3pPr>
            <a:lvl4pPr>
              <a:defRPr sz="5400"/>
            </a:lvl4pPr>
            <a:lvl5pPr>
              <a:defRPr sz="5400"/>
            </a:lvl5pPr>
            <a:lvl6pPr>
              <a:defRPr sz="5400"/>
            </a:lvl6pPr>
            <a:lvl7pPr>
              <a:defRPr sz="5400"/>
            </a:lvl7pPr>
            <a:lvl8pPr>
              <a:defRPr sz="5400"/>
            </a:lvl8pPr>
            <a:lvl9pPr>
              <a:defRPr sz="54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00571" y="7761922"/>
            <a:ext cx="7962781" cy="14379922"/>
          </a:xfrm>
        </p:spPr>
        <p:txBody>
          <a:bodyPr/>
          <a:lstStyle>
            <a:lvl1pPr marL="0" indent="0">
              <a:buNone/>
              <a:defRPr sz="4320"/>
            </a:lvl1pPr>
            <a:lvl2pPr marL="1234440" indent="0">
              <a:buNone/>
              <a:defRPr sz="3780"/>
            </a:lvl2pPr>
            <a:lvl3pPr marL="2468880" indent="0">
              <a:buNone/>
              <a:defRPr sz="3240"/>
            </a:lvl3pPr>
            <a:lvl4pPr marL="3703320" indent="0">
              <a:buNone/>
              <a:defRPr sz="2700"/>
            </a:lvl4pPr>
            <a:lvl5pPr marL="4937760" indent="0">
              <a:buNone/>
              <a:defRPr sz="2700"/>
            </a:lvl5pPr>
            <a:lvl6pPr marL="6172200" indent="0">
              <a:buNone/>
              <a:defRPr sz="2700"/>
            </a:lvl6pPr>
            <a:lvl7pPr marL="7406640" indent="0">
              <a:buNone/>
              <a:defRPr sz="2700"/>
            </a:lvl7pPr>
            <a:lvl8pPr marL="8641080" indent="0">
              <a:buNone/>
              <a:defRPr sz="2700"/>
            </a:lvl8pPr>
            <a:lvl9pPr marL="9875520" indent="0">
              <a:buNone/>
              <a:defRPr sz="27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525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1" y="1724872"/>
            <a:ext cx="7962781" cy="6037051"/>
          </a:xfrm>
        </p:spPr>
        <p:txBody>
          <a:bodyPr anchor="b"/>
          <a:lstStyle>
            <a:lvl1pPr>
              <a:defRPr sz="864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495956" y="3725249"/>
            <a:ext cx="12498705" cy="18386653"/>
          </a:xfrm>
        </p:spPr>
        <p:txBody>
          <a:bodyPr anchor="t"/>
          <a:lstStyle>
            <a:lvl1pPr marL="0" indent="0">
              <a:buNone/>
              <a:defRPr sz="8640"/>
            </a:lvl1pPr>
            <a:lvl2pPr marL="1234440" indent="0">
              <a:buNone/>
              <a:defRPr sz="7560"/>
            </a:lvl2pPr>
            <a:lvl3pPr marL="2468880" indent="0">
              <a:buNone/>
              <a:defRPr sz="6480"/>
            </a:lvl3pPr>
            <a:lvl4pPr marL="3703320" indent="0">
              <a:buNone/>
              <a:defRPr sz="5400"/>
            </a:lvl4pPr>
            <a:lvl5pPr marL="4937760" indent="0">
              <a:buNone/>
              <a:defRPr sz="5400"/>
            </a:lvl5pPr>
            <a:lvl6pPr marL="6172200" indent="0">
              <a:buNone/>
              <a:defRPr sz="5400"/>
            </a:lvl6pPr>
            <a:lvl7pPr marL="7406640" indent="0">
              <a:buNone/>
              <a:defRPr sz="5400"/>
            </a:lvl7pPr>
            <a:lvl8pPr marL="8641080" indent="0">
              <a:buNone/>
              <a:defRPr sz="5400"/>
            </a:lvl8pPr>
            <a:lvl9pPr marL="9875520" indent="0">
              <a:buNone/>
              <a:defRPr sz="54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00571" y="7761922"/>
            <a:ext cx="7962781" cy="14379922"/>
          </a:xfrm>
        </p:spPr>
        <p:txBody>
          <a:bodyPr/>
          <a:lstStyle>
            <a:lvl1pPr marL="0" indent="0">
              <a:buNone/>
              <a:defRPr sz="4320"/>
            </a:lvl1pPr>
            <a:lvl2pPr marL="1234440" indent="0">
              <a:buNone/>
              <a:defRPr sz="3780"/>
            </a:lvl2pPr>
            <a:lvl3pPr marL="2468880" indent="0">
              <a:buNone/>
              <a:defRPr sz="3240"/>
            </a:lvl3pPr>
            <a:lvl4pPr marL="3703320" indent="0">
              <a:buNone/>
              <a:defRPr sz="2700"/>
            </a:lvl4pPr>
            <a:lvl5pPr marL="4937760" indent="0">
              <a:buNone/>
              <a:defRPr sz="2700"/>
            </a:lvl5pPr>
            <a:lvl6pPr marL="6172200" indent="0">
              <a:buNone/>
              <a:defRPr sz="2700"/>
            </a:lvl6pPr>
            <a:lvl7pPr marL="7406640" indent="0">
              <a:buNone/>
              <a:defRPr sz="2700"/>
            </a:lvl7pPr>
            <a:lvl8pPr marL="8641080" indent="0">
              <a:buNone/>
              <a:defRPr sz="2700"/>
            </a:lvl8pPr>
            <a:lvl9pPr marL="9875520" indent="0">
              <a:buNone/>
              <a:defRPr sz="27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501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97355" y="1377507"/>
            <a:ext cx="21294090" cy="50009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97355" y="6887509"/>
            <a:ext cx="21294090" cy="164162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97355" y="23980513"/>
            <a:ext cx="5554980" cy="13775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C75C1-084C-48BC-826D-8AEF154C7E79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178165" y="23980513"/>
            <a:ext cx="8332470" cy="13775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436465" y="23980513"/>
            <a:ext cx="5554980" cy="13775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35B81-AD2A-438F-90B4-D61930AB9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867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468880" rtl="0" eaLnBrk="1" latinLnBrk="0" hangingPunct="1">
        <a:lnSpc>
          <a:spcPct val="90000"/>
        </a:lnSpc>
        <a:spcBef>
          <a:spcPct val="0"/>
        </a:spcBef>
        <a:buNone/>
        <a:defRPr sz="118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17220" indent="-617220" algn="l" defTabSz="2468880" rtl="0" eaLnBrk="1" latinLnBrk="0" hangingPunct="1">
        <a:lnSpc>
          <a:spcPct val="90000"/>
        </a:lnSpc>
        <a:spcBef>
          <a:spcPts val="27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1pPr>
      <a:lvl2pPr marL="185166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2pPr>
      <a:lvl3pPr marL="308610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32054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4pPr>
      <a:lvl5pPr marL="555498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5pPr>
      <a:lvl6pPr marL="678942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6pPr>
      <a:lvl7pPr marL="802386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7pPr>
      <a:lvl8pPr marL="925830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8pPr>
      <a:lvl9pPr marL="10492740" indent="-617220" algn="l" defTabSz="246888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1pPr>
      <a:lvl2pPr marL="123444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2pPr>
      <a:lvl3pPr marL="246888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3pPr>
      <a:lvl4pPr marL="370332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4pPr>
      <a:lvl5pPr marL="493776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5pPr>
      <a:lvl6pPr marL="617220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6pPr>
      <a:lvl7pPr marL="740664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7pPr>
      <a:lvl8pPr marL="864108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8pPr>
      <a:lvl9pPr marL="9875520" algn="l" defTabSz="2468880" rtl="0" eaLnBrk="1" latinLnBrk="0" hangingPunct="1">
        <a:defRPr sz="48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862C72D7-648F-D25D-B6C3-839A67065B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7200"/>
            <a:ext cx="8229600" cy="5084064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84B779E9-0272-F221-B302-E217A90AFD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457200"/>
            <a:ext cx="8229600" cy="5084064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8861D7E7-B318-60A9-F834-2C3BA8BCA2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457200"/>
            <a:ext cx="8229600" cy="5084064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D9C644BE-19AA-CF8E-0182-7005113C3CE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37263"/>
            <a:ext cx="8229600" cy="5084064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56BF5BD1-DA1B-19ED-3664-C1B53FC0F65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5537263"/>
            <a:ext cx="8229600" cy="5084064"/>
          </a:xfrm>
          <a:prstGeom prst="rect">
            <a:avLst/>
          </a:prstGeom>
        </p:spPr>
      </p:pic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9A37E7DC-31E7-C070-8526-A3A51BA1C98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5537263"/>
            <a:ext cx="8229600" cy="5084064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116BD8B2-355E-1BF0-55CE-5465DCCAEB8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617326"/>
            <a:ext cx="8229600" cy="508406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540148C-7694-C552-A761-5F569B160E3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10617326"/>
            <a:ext cx="8229600" cy="5084064"/>
          </a:xfrm>
          <a:prstGeom prst="rect">
            <a:avLst/>
          </a:prstGeom>
        </p:spPr>
      </p:pic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ED4F0231-9CE0-E3B5-8EC5-A3E8C7D4C8A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10617326"/>
            <a:ext cx="8229600" cy="5084064"/>
          </a:xfrm>
          <a:prstGeom prst="rect">
            <a:avLst/>
          </a:prstGeom>
        </p:spPr>
      </p:pic>
      <p:pic>
        <p:nvPicPr>
          <p:cNvPr id="13" name="Picture 12" descr="Chart, scatter chart&#10;&#10;Description automatically generated">
            <a:extLst>
              <a:ext uri="{FF2B5EF4-FFF2-40B4-BE49-F238E27FC236}">
                <a16:creationId xmlns:a16="http://schemas.microsoft.com/office/drawing/2014/main" id="{B601629F-AE5A-FB23-7673-2B790AB7996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701390"/>
            <a:ext cx="8229600" cy="5084064"/>
          </a:xfrm>
          <a:prstGeom prst="rect">
            <a:avLst/>
          </a:prstGeom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FAACCFA3-FBA5-4603-EACA-B927EC493B4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15701390"/>
            <a:ext cx="8229600" cy="5084064"/>
          </a:xfrm>
          <a:prstGeom prst="rect">
            <a:avLst/>
          </a:prstGeom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EDCBF7BF-8F50-F49C-BFFB-A52AA4814D5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15701390"/>
            <a:ext cx="8229600" cy="5084064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0CB19E78-9857-D4B7-0EB3-45220A9C5DA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20789011"/>
            <a:ext cx="8229600" cy="5084064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2BF68BD0-2481-F2E8-D1E3-AB19636F6D66}"/>
              </a:ext>
            </a:extLst>
          </p:cNvPr>
          <p:cNvSpPr/>
          <p:nvPr/>
        </p:nvSpPr>
        <p:spPr>
          <a:xfrm flipH="1">
            <a:off x="0" y="553993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D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EB12FC9-E458-B423-FB1E-A45397620105}"/>
              </a:ext>
            </a:extLst>
          </p:cNvPr>
          <p:cNvSpPr/>
          <p:nvPr/>
        </p:nvSpPr>
        <p:spPr>
          <a:xfrm flipH="1">
            <a:off x="8229600" y="553993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E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2C0B5C0-DE5B-A395-E014-65A291B6B73B}"/>
              </a:ext>
            </a:extLst>
          </p:cNvPr>
          <p:cNvSpPr/>
          <p:nvPr/>
        </p:nvSpPr>
        <p:spPr>
          <a:xfrm flipH="1">
            <a:off x="16459200" y="553993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F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B8CC0F0-2A0B-B2BF-0B32-9B8778452215}"/>
              </a:ext>
            </a:extLst>
          </p:cNvPr>
          <p:cNvSpPr/>
          <p:nvPr/>
        </p:nvSpPr>
        <p:spPr>
          <a:xfrm flipH="1">
            <a:off x="-1" y="457199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AD99CE1-8F06-B0BF-15D9-8607385E4D73}"/>
              </a:ext>
            </a:extLst>
          </p:cNvPr>
          <p:cNvSpPr/>
          <p:nvPr/>
        </p:nvSpPr>
        <p:spPr>
          <a:xfrm flipH="1">
            <a:off x="8229600" y="45720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0B8EE2F-8EB1-B011-78F3-BEC41EBF09FB}"/>
              </a:ext>
            </a:extLst>
          </p:cNvPr>
          <p:cNvSpPr/>
          <p:nvPr/>
        </p:nvSpPr>
        <p:spPr>
          <a:xfrm flipH="1">
            <a:off x="16459200" y="45319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90518CDE-0D08-2C59-D279-7B3C36104BB6}"/>
              </a:ext>
            </a:extLst>
          </p:cNvPr>
          <p:cNvSpPr/>
          <p:nvPr/>
        </p:nvSpPr>
        <p:spPr>
          <a:xfrm flipH="1">
            <a:off x="8229600" y="1062266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H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CEA0A3E-50BC-0D8F-9717-A314313E32DA}"/>
              </a:ext>
            </a:extLst>
          </p:cNvPr>
          <p:cNvSpPr/>
          <p:nvPr/>
        </p:nvSpPr>
        <p:spPr>
          <a:xfrm flipH="1">
            <a:off x="-2" y="10613769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G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AE97400-5E0B-7C3C-07E7-3872D31A67B3}"/>
              </a:ext>
            </a:extLst>
          </p:cNvPr>
          <p:cNvSpPr/>
          <p:nvPr/>
        </p:nvSpPr>
        <p:spPr>
          <a:xfrm flipH="1">
            <a:off x="16459200" y="10617326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I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9FE966F-3178-35C2-D3C5-EC7BA86E6F0D}"/>
              </a:ext>
            </a:extLst>
          </p:cNvPr>
          <p:cNvSpPr/>
          <p:nvPr/>
        </p:nvSpPr>
        <p:spPr>
          <a:xfrm flipH="1">
            <a:off x="8229600" y="1570139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K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B1B1906-2279-3EAB-B571-21A25F37528E}"/>
              </a:ext>
            </a:extLst>
          </p:cNvPr>
          <p:cNvSpPr/>
          <p:nvPr/>
        </p:nvSpPr>
        <p:spPr>
          <a:xfrm flipH="1">
            <a:off x="0" y="1570139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J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3FBEC97-06D8-60B0-8462-EA96465135DC}"/>
              </a:ext>
            </a:extLst>
          </p:cNvPr>
          <p:cNvSpPr/>
          <p:nvPr/>
        </p:nvSpPr>
        <p:spPr>
          <a:xfrm flipH="1">
            <a:off x="8229600" y="2078901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M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ACC29F2-311E-FF7F-5F50-851E42658A0A}"/>
              </a:ext>
            </a:extLst>
          </p:cNvPr>
          <p:cNvSpPr/>
          <p:nvPr/>
        </p:nvSpPr>
        <p:spPr>
          <a:xfrm flipH="1">
            <a:off x="16459200" y="15701390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L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CA22923-1A75-4AF0-88F7-F45019298673}"/>
              </a:ext>
            </a:extLst>
          </p:cNvPr>
          <p:cNvSpPr/>
          <p:nvPr/>
        </p:nvSpPr>
        <p:spPr>
          <a:xfrm>
            <a:off x="0" y="0"/>
            <a:ext cx="24688800" cy="4545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b="1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4. </a:t>
            </a:r>
            <a:r>
              <a:rPr lang="en-US" sz="2000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 of monthly OPD visits per 100 UCS beneficiaries from January 2017 to December 2020, stratified by health regions</a:t>
            </a:r>
            <a:endParaRPr lang="en-GB" sz="20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434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7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awee Sukmanee</dc:creator>
  <cp:lastModifiedBy>Jarawee Sukmanee</cp:lastModifiedBy>
  <cp:revision>1</cp:revision>
  <dcterms:created xsi:type="dcterms:W3CDTF">2023-01-09T14:48:15Z</dcterms:created>
  <dcterms:modified xsi:type="dcterms:W3CDTF">2023-01-09T14:49:31Z</dcterms:modified>
</cp:coreProperties>
</file>